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1" autoAdjust="0"/>
    <p:restoredTop sz="94652"/>
  </p:normalViewPr>
  <p:slideViewPr>
    <p:cSldViewPr snapToGrid="0">
      <p:cViewPr varScale="1">
        <p:scale>
          <a:sx n="133" d="100"/>
          <a:sy n="133" d="100"/>
        </p:scale>
        <p:origin x="188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25823-1552-4063-95CC-F0480CFDC0CA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D180E-E626-489A-A6F1-6A0011BC3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459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25823-1552-4063-95CC-F0480CFDC0CA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D180E-E626-489A-A6F1-6A0011BC3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4862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25823-1552-4063-95CC-F0480CFDC0CA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D180E-E626-489A-A6F1-6A0011BC3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538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25823-1552-4063-95CC-F0480CFDC0CA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D180E-E626-489A-A6F1-6A0011BC3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783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25823-1552-4063-95CC-F0480CFDC0CA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D180E-E626-489A-A6F1-6A0011BC3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9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25823-1552-4063-95CC-F0480CFDC0CA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D180E-E626-489A-A6F1-6A0011BC3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981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25823-1552-4063-95CC-F0480CFDC0CA}" type="datetimeFigureOut">
              <a:rPr lang="en-US" smtClean="0"/>
              <a:t>6/2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D180E-E626-489A-A6F1-6A0011BC3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266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25823-1552-4063-95CC-F0480CFDC0CA}" type="datetimeFigureOut">
              <a:rPr lang="en-US" smtClean="0"/>
              <a:t>6/2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D180E-E626-489A-A6F1-6A0011BC3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67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25823-1552-4063-95CC-F0480CFDC0CA}" type="datetimeFigureOut">
              <a:rPr lang="en-US" smtClean="0"/>
              <a:t>6/2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D180E-E626-489A-A6F1-6A0011BC3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0176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25823-1552-4063-95CC-F0480CFDC0CA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D180E-E626-489A-A6F1-6A0011BC3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721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25823-1552-4063-95CC-F0480CFDC0CA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D180E-E626-489A-A6F1-6A0011BC3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571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E25823-1552-4063-95CC-F0480CFDC0CA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7D180E-E626-489A-A6F1-6A0011BC3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625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02FBAFB1-F3DC-4513-AD02-1B8910578F6F}"/>
              </a:ext>
            </a:extLst>
          </p:cNvPr>
          <p:cNvGrpSpPr/>
          <p:nvPr/>
        </p:nvGrpSpPr>
        <p:grpSpPr>
          <a:xfrm>
            <a:off x="168443" y="492766"/>
            <a:ext cx="8807115" cy="4791503"/>
            <a:chOff x="477356" y="1327422"/>
            <a:chExt cx="7983949" cy="4220685"/>
          </a:xfrm>
        </p:grpSpPr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DDA87E87-2155-45F0-A181-EE81C9204AF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77356" y="1344952"/>
              <a:ext cx="4090463" cy="4203155"/>
              <a:chOff x="2952040" y="303570"/>
              <a:chExt cx="3025606" cy="3108960"/>
            </a:xfrm>
          </p:grpSpPr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069E311B-9E80-41D2-A3F7-2520D3930DAE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166353" y="303570"/>
                <a:ext cx="2811293" cy="3108960"/>
                <a:chOff x="1134825" y="990525"/>
                <a:chExt cx="2550000" cy="2820000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C512C5D3-0405-4572-8FE6-0355667168D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34825" y="990525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7" name="Picture 6">
                  <a:extLst>
                    <a:ext uri="{FF2B5EF4-FFF2-40B4-BE49-F238E27FC236}">
                      <a16:creationId xmlns:a16="http://schemas.microsoft.com/office/drawing/2014/main" id="{8019666E-A5FC-4118-87F7-5BC81C202AE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34825" y="1695525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D6253AB1-FDEA-431E-8EDE-9785A64472D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34825" y="2400525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6B2B33BE-E90C-4004-978E-46A38E67C3A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34825" y="3105525"/>
                  <a:ext cx="2550000" cy="705000"/>
                </a:xfrm>
                <a:prstGeom prst="rect">
                  <a:avLst/>
                </a:prstGeom>
              </p:spPr>
            </p:pic>
          </p:grp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B7D12E02-709B-4E02-B22B-6AFD66741BEB}"/>
                  </a:ext>
                </a:extLst>
              </p:cNvPr>
              <p:cNvSpPr txBox="1"/>
              <p:nvPr/>
            </p:nvSpPr>
            <p:spPr>
              <a:xfrm>
                <a:off x="2952040" y="348298"/>
                <a:ext cx="4286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B7FE3669-788C-424B-8AAF-4AD64A1428C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424862" y="1327422"/>
              <a:ext cx="4036443" cy="4147647"/>
              <a:chOff x="2952040" y="3445471"/>
              <a:chExt cx="3025606" cy="3108960"/>
            </a:xfrm>
          </p:grpSpPr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D744941A-7416-40FC-8BE2-C9469834DD08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166353" y="3445471"/>
                <a:ext cx="2811293" cy="3108960"/>
                <a:chOff x="4821000" y="990525"/>
                <a:chExt cx="2550000" cy="2820000"/>
              </a:xfrm>
            </p:grpSpPr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id="{C8D7C67D-CF4A-4C9E-8AD6-33A77AF5DE1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821000" y="990525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E59B1E92-D4F5-4EB9-8564-F711FAD82D3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821000" y="1695525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7" name="Picture 16">
                  <a:extLst>
                    <a:ext uri="{FF2B5EF4-FFF2-40B4-BE49-F238E27FC236}">
                      <a16:creationId xmlns:a16="http://schemas.microsoft.com/office/drawing/2014/main" id="{60AA9EE3-42D0-4FC8-95B9-863D3770CF1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821000" y="2400525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9" name="Picture 18">
                  <a:extLst>
                    <a:ext uri="{FF2B5EF4-FFF2-40B4-BE49-F238E27FC236}">
                      <a16:creationId xmlns:a16="http://schemas.microsoft.com/office/drawing/2014/main" id="{5F60A0A1-C703-45E3-AF93-3D60C15B0EE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821000" y="3105525"/>
                  <a:ext cx="2550000" cy="705000"/>
                </a:xfrm>
                <a:prstGeom prst="rect">
                  <a:avLst/>
                </a:prstGeom>
              </p:spPr>
            </p:pic>
          </p:grp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BDB9377E-7881-4A7A-8630-3BE2980C9AFC}"/>
                  </a:ext>
                </a:extLst>
              </p:cNvPr>
              <p:cNvSpPr txBox="1"/>
              <p:nvPr/>
            </p:nvSpPr>
            <p:spPr>
              <a:xfrm>
                <a:off x="2952040" y="3480674"/>
                <a:ext cx="4286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</p:grp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5D64882C-ECA9-4DFE-885F-DF6D442FBA68}"/>
              </a:ext>
            </a:extLst>
          </p:cNvPr>
          <p:cNvSpPr txBox="1"/>
          <p:nvPr/>
        </p:nvSpPr>
        <p:spPr>
          <a:xfrm>
            <a:off x="819200" y="5510878"/>
            <a:ext cx="769421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 Fig. PpSP32 nucleotide and amino acid variation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blo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lustrating the relative frequencies of nucleotide polymorphisms in wild caugh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apatas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s from PPAW, PPJM, and PPJS. (B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blo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lustrating the relative frequencies of amino acid polymorphisms in wild caugh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apatas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s from PPAW, PPJM, and PPJS.</a:t>
            </a:r>
          </a:p>
        </p:txBody>
      </p:sp>
    </p:spTree>
    <p:extLst>
      <p:ext uri="{BB962C8B-B14F-4D97-AF65-F5344CB8AC3E}">
        <p14:creationId xmlns:p14="http://schemas.microsoft.com/office/powerpoint/2010/main" val="7658288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5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te Flanley</dc:creator>
  <cp:lastModifiedBy>Cate Flanley</cp:lastModifiedBy>
  <cp:revision>3</cp:revision>
  <dcterms:created xsi:type="dcterms:W3CDTF">2019-01-18T03:12:03Z</dcterms:created>
  <dcterms:modified xsi:type="dcterms:W3CDTF">2020-06-21T17:47:45Z</dcterms:modified>
</cp:coreProperties>
</file>